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4"/>
  </p:notesMasterIdLst>
  <p:sldIdLst>
    <p:sldId id="263" r:id="rId3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74" userDrawn="1">
          <p15:clr>
            <a:srgbClr val="A4A3A4"/>
          </p15:clr>
        </p15:guide>
        <p15:guide id="3" pos="3651" userDrawn="1">
          <p15:clr>
            <a:srgbClr val="A4A3A4"/>
          </p15:clr>
        </p15:guide>
        <p15:guide id="4" pos="90" userDrawn="1">
          <p15:clr>
            <a:srgbClr val="A4A3A4"/>
          </p15:clr>
        </p15:guide>
        <p15:guide id="5" orient="horz" pos="2341" userDrawn="1">
          <p15:clr>
            <a:srgbClr val="A4A3A4"/>
          </p15:clr>
        </p15:guide>
        <p15:guide id="6" orient="horz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3716" autoAdjust="0"/>
  </p:normalViewPr>
  <p:slideViewPr>
    <p:cSldViewPr snapToGrid="0" showGuides="1">
      <p:cViewPr>
        <p:scale>
          <a:sx n="100" d="100"/>
          <a:sy n="100" d="100"/>
        </p:scale>
        <p:origin x="432" y="72"/>
      </p:cViewPr>
      <p:guideLst>
        <p:guide orient="horz" pos="3974"/>
        <p:guide pos="3651"/>
        <p:guide pos="90"/>
        <p:guide orient="horz" pos="2341"/>
        <p:guide orient="horz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dcbcpbsna01a\pbs_home$\MullerA\Microarray%20sockeye%20salmon\mueller-matrix_dec3-1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dcbcpbsna01a\pbs_home$\MullerA\Microarray%20sockeye%20salmon\mueller-matrix_dec3-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slope</c:v>
          </c:tx>
          <c:spPr>
            <a:solidFill>
              <a:schemeClr val="tx1">
                <a:lumMod val="85000"/>
                <a:lumOff val="15000"/>
              </a:schemeClr>
            </a:solidFill>
          </c:spPr>
          <c:invertIfNegative val="0"/>
          <c:cat>
            <c:strRef>
              <c:f>'[mueller-matrix_dec3-13.xlsx]corr-slope-Rsqu'!$C$4:$C$18</c:f>
              <c:strCache>
                <c:ptCount val="15"/>
                <c:pt idx="0">
                  <c:v>Mx-C041R022</c:v>
                </c:pt>
                <c:pt idx="1">
                  <c:v>SACS-C100R146</c:v>
                </c:pt>
                <c:pt idx="2">
                  <c:v>Mx-C236R043</c:v>
                </c:pt>
                <c:pt idx="3">
                  <c:v>Ig Hcmu sec-C017R015</c:v>
                </c:pt>
                <c:pt idx="4">
                  <c:v>LGALS3BP-C065R010</c:v>
                </c:pt>
                <c:pt idx="5">
                  <c:v>Ig Hcmu memb-C078R010</c:v>
                </c:pt>
                <c:pt idx="6">
                  <c:v>Mx-C030R081</c:v>
                </c:pt>
                <c:pt idx="7">
                  <c:v>EPD2-C115R067</c:v>
                </c:pt>
                <c:pt idx="8">
                  <c:v>CEBPD-C026R028</c:v>
                </c:pt>
                <c:pt idx="9">
                  <c:v>RTP3-C183R035</c:v>
                </c:pt>
                <c:pt idx="10">
                  <c:v>C7-C044R130</c:v>
                </c:pt>
                <c:pt idx="11">
                  <c:v>C1S-C024R158</c:v>
                </c:pt>
                <c:pt idx="12">
                  <c:v>SQLE-C140R097</c:v>
                </c:pt>
                <c:pt idx="13">
                  <c:v>FDPS-C078R087</c:v>
                </c:pt>
                <c:pt idx="14">
                  <c:v>B3GALTL-C068R168</c:v>
                </c:pt>
              </c:strCache>
            </c:strRef>
          </c:cat>
          <c:val>
            <c:numRef>
              <c:f>'[mueller-matrix_dec3-13.xlsx]corr-slope-Rsqu'!$D$4:$D$18</c:f>
              <c:numCache>
                <c:formatCode>General</c:formatCode>
                <c:ptCount val="15"/>
                <c:pt idx="0">
                  <c:v>1.1729000000000001</c:v>
                </c:pt>
                <c:pt idx="1">
                  <c:v>1.0867</c:v>
                </c:pt>
                <c:pt idx="2">
                  <c:v>1.036</c:v>
                </c:pt>
                <c:pt idx="3">
                  <c:v>1.2553000000000001</c:v>
                </c:pt>
                <c:pt idx="4">
                  <c:v>1.1192</c:v>
                </c:pt>
                <c:pt idx="5">
                  <c:v>1.4539</c:v>
                </c:pt>
                <c:pt idx="6">
                  <c:v>1.9367000000000001</c:v>
                </c:pt>
                <c:pt idx="7">
                  <c:v>0.94099999999999995</c:v>
                </c:pt>
                <c:pt idx="8">
                  <c:v>0.91239999999999999</c:v>
                </c:pt>
                <c:pt idx="9">
                  <c:v>1.2165999999999999</c:v>
                </c:pt>
                <c:pt idx="10">
                  <c:v>0.77680000000000005</c:v>
                </c:pt>
                <c:pt idx="11">
                  <c:v>1.0817000000000001</c:v>
                </c:pt>
                <c:pt idx="12">
                  <c:v>1.0190999999999999</c:v>
                </c:pt>
                <c:pt idx="13">
                  <c:v>0.47370000000000001</c:v>
                </c:pt>
                <c:pt idx="14">
                  <c:v>0.12670000000000001</c:v>
                </c:pt>
              </c:numCache>
            </c:numRef>
          </c:val>
        </c:ser>
        <c:ser>
          <c:idx val="1"/>
          <c:order val="1"/>
          <c:tx>
            <c:strRef>
              <c:f>'[mueller-matrix_dec3-13.xlsx]corr-slope-Rsqu'!$E$3</c:f>
              <c:strCache>
                <c:ptCount val="1"/>
                <c:pt idx="0">
                  <c:v>Rsq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cat>
            <c:strRef>
              <c:f>'[mueller-matrix_dec3-13.xlsx]corr-slope-Rsqu'!$C$4:$C$18</c:f>
              <c:strCache>
                <c:ptCount val="15"/>
                <c:pt idx="0">
                  <c:v>Mx-C041R022</c:v>
                </c:pt>
                <c:pt idx="1">
                  <c:v>SACS-C100R146</c:v>
                </c:pt>
                <c:pt idx="2">
                  <c:v>Mx-C236R043</c:v>
                </c:pt>
                <c:pt idx="3">
                  <c:v>Ig Hcmu sec-C017R015</c:v>
                </c:pt>
                <c:pt idx="4">
                  <c:v>LGALS3BP-C065R010</c:v>
                </c:pt>
                <c:pt idx="5">
                  <c:v>Ig Hcmu memb-C078R010</c:v>
                </c:pt>
                <c:pt idx="6">
                  <c:v>Mx-C030R081</c:v>
                </c:pt>
                <c:pt idx="7">
                  <c:v>EPD2-C115R067</c:v>
                </c:pt>
                <c:pt idx="8">
                  <c:v>CEBPD-C026R028</c:v>
                </c:pt>
                <c:pt idx="9">
                  <c:v>RTP3-C183R035</c:v>
                </c:pt>
                <c:pt idx="10">
                  <c:v>C7-C044R130</c:v>
                </c:pt>
                <c:pt idx="11">
                  <c:v>C1S-C024R158</c:v>
                </c:pt>
                <c:pt idx="12">
                  <c:v>SQLE-C140R097</c:v>
                </c:pt>
                <c:pt idx="13">
                  <c:v>FDPS-C078R087</c:v>
                </c:pt>
                <c:pt idx="14">
                  <c:v>B3GALTL-C068R168</c:v>
                </c:pt>
              </c:strCache>
            </c:strRef>
          </c:cat>
          <c:val>
            <c:numRef>
              <c:f>'[mueller-matrix_dec3-13.xlsx]corr-slope-Rsqu'!$E$4:$E$18</c:f>
              <c:numCache>
                <c:formatCode>General</c:formatCode>
                <c:ptCount val="15"/>
                <c:pt idx="0">
                  <c:v>0.97470000000000001</c:v>
                </c:pt>
                <c:pt idx="1">
                  <c:v>0.96540000000000004</c:v>
                </c:pt>
                <c:pt idx="2">
                  <c:v>0.95920000000000005</c:v>
                </c:pt>
                <c:pt idx="3">
                  <c:v>0.89810000000000001</c:v>
                </c:pt>
                <c:pt idx="4">
                  <c:v>0.88029999999999997</c:v>
                </c:pt>
                <c:pt idx="5">
                  <c:v>0.87309999999999999</c:v>
                </c:pt>
                <c:pt idx="6">
                  <c:v>0.85699999999999998</c:v>
                </c:pt>
                <c:pt idx="7">
                  <c:v>0.73560000000000003</c:v>
                </c:pt>
                <c:pt idx="8">
                  <c:v>0.73519999999999996</c:v>
                </c:pt>
                <c:pt idx="9">
                  <c:v>0.7137</c:v>
                </c:pt>
                <c:pt idx="10">
                  <c:v>0.70730000000000004</c:v>
                </c:pt>
                <c:pt idx="11">
                  <c:v>0.68369999999999997</c:v>
                </c:pt>
                <c:pt idx="12">
                  <c:v>0.65329999999999999</c:v>
                </c:pt>
                <c:pt idx="13">
                  <c:v>0.48799999999999999</c:v>
                </c:pt>
                <c:pt idx="14">
                  <c:v>0.1681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848488"/>
        <c:axId val="99849272"/>
      </c:barChart>
      <c:catAx>
        <c:axId val="998484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99849272"/>
        <c:crosses val="autoZero"/>
        <c:auto val="1"/>
        <c:lblAlgn val="ctr"/>
        <c:lblOffset val="100"/>
        <c:noMultiLvlLbl val="0"/>
      </c:catAx>
      <c:valAx>
        <c:axId val="99849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998484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2862598425196845"/>
          <c:y val="0.18480132691746864"/>
          <c:w val="0.1074851268591426"/>
          <c:h val="0.1674343832020997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23640135608048993"/>
                  <c:y val="5.4328521434820649E-2"/>
                </c:manualLayout>
              </c:layout>
              <c:numFmt formatCode="General" sourceLinked="0"/>
            </c:trendlineLbl>
          </c:trendline>
          <c:xVal>
            <c:numRef>
              <c:f>'[mueller-matrix_dec3-13.xlsx]selected probes_manus2by3'!$E$9:$E$43</c:f>
              <c:numCache>
                <c:formatCode>General</c:formatCode>
                <c:ptCount val="35"/>
                <c:pt idx="0">
                  <c:v>-2.9803190000000002</c:v>
                </c:pt>
                <c:pt idx="1">
                  <c:v>-3.5825900000000002</c:v>
                </c:pt>
                <c:pt idx="2">
                  <c:v>-3.7931957000000001</c:v>
                </c:pt>
                <c:pt idx="3">
                  <c:v>-4.0918970000000003</c:v>
                </c:pt>
                <c:pt idx="4">
                  <c:v>-3.6980781999999999</c:v>
                </c:pt>
                <c:pt idx="5">
                  <c:v>-2.7892969999999999</c:v>
                </c:pt>
                <c:pt idx="6">
                  <c:v>-2.7138003999999998</c:v>
                </c:pt>
                <c:pt idx="7">
                  <c:v>-1.2276001000000001</c:v>
                </c:pt>
                <c:pt idx="8">
                  <c:v>1.4711989999999999</c:v>
                </c:pt>
                <c:pt idx="9">
                  <c:v>-0.11840534</c:v>
                </c:pt>
                <c:pt idx="10">
                  <c:v>0.90532590000000002</c:v>
                </c:pt>
                <c:pt idx="11">
                  <c:v>0.17325592000000001</c:v>
                </c:pt>
                <c:pt idx="12">
                  <c:v>-3.7442074000000001</c:v>
                </c:pt>
                <c:pt idx="13">
                  <c:v>1.2644147999999999</c:v>
                </c:pt>
                <c:pt idx="14">
                  <c:v>-3.8191147000000001</c:v>
                </c:pt>
                <c:pt idx="15">
                  <c:v>-4.9886569999999999</c:v>
                </c:pt>
                <c:pt idx="16">
                  <c:v>-3.6206312</c:v>
                </c:pt>
                <c:pt idx="17">
                  <c:v>-4.7156599999999997</c:v>
                </c:pt>
                <c:pt idx="18">
                  <c:v>-3.7960699999999998</c:v>
                </c:pt>
                <c:pt idx="19">
                  <c:v>-3.7985066999999999</c:v>
                </c:pt>
                <c:pt idx="20">
                  <c:v>-1.9791650999999999</c:v>
                </c:pt>
                <c:pt idx="21">
                  <c:v>-1.9763002000000001</c:v>
                </c:pt>
                <c:pt idx="22">
                  <c:v>-4.185155</c:v>
                </c:pt>
                <c:pt idx="23">
                  <c:v>-3.3613740000000001</c:v>
                </c:pt>
                <c:pt idx="24">
                  <c:v>1.4734106</c:v>
                </c:pt>
                <c:pt idx="25">
                  <c:v>2.0474348</c:v>
                </c:pt>
                <c:pt idx="26">
                  <c:v>0.93445396000000003</c:v>
                </c:pt>
                <c:pt idx="27">
                  <c:v>1.9660405999999999</c:v>
                </c:pt>
                <c:pt idx="28">
                  <c:v>0.87200736999999995</c:v>
                </c:pt>
                <c:pt idx="29">
                  <c:v>1.0572119</c:v>
                </c:pt>
                <c:pt idx="30">
                  <c:v>1.0622434999999999</c:v>
                </c:pt>
                <c:pt idx="31">
                  <c:v>1.8524189</c:v>
                </c:pt>
                <c:pt idx="32">
                  <c:v>1.8175659</c:v>
                </c:pt>
                <c:pt idx="33">
                  <c:v>-4.0199049999999996</c:v>
                </c:pt>
                <c:pt idx="34">
                  <c:v>-3.8515844000000001</c:v>
                </c:pt>
              </c:numCache>
            </c:numRef>
          </c:xVal>
          <c:yVal>
            <c:numRef>
              <c:f>'[mueller-matrix_dec3-13.xlsx]selected probes_manus2by3'!$I$9:$I$43</c:f>
              <c:numCache>
                <c:formatCode>General</c:formatCode>
                <c:ptCount val="35"/>
                <c:pt idx="0">
                  <c:v>0.16341197424503837</c:v>
                </c:pt>
                <c:pt idx="1">
                  <c:v>-0.18636574663987646</c:v>
                </c:pt>
                <c:pt idx="2">
                  <c:v>0.20081282574119799</c:v>
                </c:pt>
                <c:pt idx="3">
                  <c:v>-1.6184742030780881</c:v>
                </c:pt>
                <c:pt idx="4">
                  <c:v>-0.40398378898677018</c:v>
                </c:pt>
                <c:pt idx="5">
                  <c:v>0.9050378906462947</c:v>
                </c:pt>
                <c:pt idx="6">
                  <c:v>0.93956104807220353</c:v>
                </c:pt>
                <c:pt idx="7">
                  <c:v>1.5838473948552354</c:v>
                </c:pt>
                <c:pt idx="8">
                  <c:v>4.6688916906395788</c:v>
                </c:pt>
                <c:pt idx="9">
                  <c:v>3.7102457229198818</c:v>
                </c:pt>
                <c:pt idx="10">
                  <c:v>5.0390469635773671</c:v>
                </c:pt>
                <c:pt idx="11">
                  <c:v>4.050948498051592</c:v>
                </c:pt>
                <c:pt idx="12">
                  <c:v>0.1592862556225452</c:v>
                </c:pt>
                <c:pt idx="13">
                  <c:v>4.9594521609403275</c:v>
                </c:pt>
                <c:pt idx="14">
                  <c:v>-1.4657961484793005</c:v>
                </c:pt>
                <c:pt idx="15">
                  <c:v>-1.951315362011935</c:v>
                </c:pt>
                <c:pt idx="16">
                  <c:v>-0.10965068209342173</c:v>
                </c:pt>
                <c:pt idx="17">
                  <c:v>-1.5156241543179194</c:v>
                </c:pt>
                <c:pt idx="18">
                  <c:v>-1.4733683545232025E-2</c:v>
                </c:pt>
                <c:pt idx="19">
                  <c:v>0.5789531913862852</c:v>
                </c:pt>
                <c:pt idx="20">
                  <c:v>0.90052643901735596</c:v>
                </c:pt>
                <c:pt idx="21">
                  <c:v>1.9556690763282651</c:v>
                </c:pt>
                <c:pt idx="22">
                  <c:v>-0.48775635274162954</c:v>
                </c:pt>
                <c:pt idx="23">
                  <c:v>0.69170169440788787</c:v>
                </c:pt>
                <c:pt idx="24">
                  <c:v>5.3271848628080933</c:v>
                </c:pt>
                <c:pt idx="25">
                  <c:v>6.1026665556130242</c:v>
                </c:pt>
                <c:pt idx="26">
                  <c:v>4.8751356926726901</c:v>
                </c:pt>
                <c:pt idx="28">
                  <c:v>5.0623195571989443</c:v>
                </c:pt>
                <c:pt idx="29">
                  <c:v>4.8312579854981257</c:v>
                </c:pt>
                <c:pt idx="30">
                  <c:v>4.1157303142933621</c:v>
                </c:pt>
                <c:pt idx="31">
                  <c:v>5.4964657888468231</c:v>
                </c:pt>
                <c:pt idx="32">
                  <c:v>5.1588335742885931</c:v>
                </c:pt>
                <c:pt idx="33">
                  <c:v>0.69672235555271433</c:v>
                </c:pt>
                <c:pt idx="34">
                  <c:v>-0.156705078852461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847704"/>
        <c:axId val="153027848"/>
      </c:scatterChart>
      <c:valAx>
        <c:axId val="998477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icroarray log2 (Mx - C236R043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3027848"/>
        <c:crossesAt val="0"/>
        <c:crossBetween val="midCat"/>
      </c:valAx>
      <c:valAx>
        <c:axId val="1530278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T-qPCR log2 (Mx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9847704"/>
        <c:crossesAt val="-6"/>
        <c:crossBetween val="midCat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74E3938C-0520-43B7-BF8E-D360F49184B2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B9C00A2D-01D1-4CBA-9FE7-DB34B99C98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051126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C00A2D-01D1-4CBA-9FE7-DB34B99C984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785311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11685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68478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6189046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5679962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430631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7297790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671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825625"/>
            <a:ext cx="38671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9456200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2623188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9814885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5273526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5438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676158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8129675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8577321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7626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712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73075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1562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01787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1010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7511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3112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35838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EA2EDC-816D-4B6B-8B4D-CD785B70411E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C7143C-91FB-4842-A8CB-53E92DBD33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32416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FC2A24-31C0-4314-BC1A-C2034D2C6BED}" type="datetimeFigureOut">
              <a:rPr lang="en-CA" smtClean="0"/>
              <a:t>2015-02-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CD8F89-9D40-4B1F-A0C0-7D8913E27D5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151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1194953"/>
              </p:ext>
            </p:extLst>
          </p:nvPr>
        </p:nvGraphicFramePr>
        <p:xfrm>
          <a:off x="1030288" y="28176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8698777"/>
              </p:ext>
            </p:extLst>
          </p:nvPr>
        </p:nvGraphicFramePr>
        <p:xfrm>
          <a:off x="1030288" y="326242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855437" y="328771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67468" y="286336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6487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04</TotalTime>
  <Words>17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Custom Design</vt:lpstr>
      <vt:lpstr>PowerPoint Presentation</vt:lpstr>
    </vt:vector>
  </TitlesOfParts>
  <Company>DFO-MP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FO-MPO</dc:creator>
  <cp:lastModifiedBy>Anita Mueller</cp:lastModifiedBy>
  <cp:revision>86</cp:revision>
  <cp:lastPrinted>2014-07-17T21:12:56Z</cp:lastPrinted>
  <dcterms:created xsi:type="dcterms:W3CDTF">2013-12-18T22:03:45Z</dcterms:created>
  <dcterms:modified xsi:type="dcterms:W3CDTF">2015-02-26T00:40:38Z</dcterms:modified>
</cp:coreProperties>
</file>